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8"/>
    <p:restoredTop sz="96208"/>
  </p:normalViewPr>
  <p:slideViewPr>
    <p:cSldViewPr snapToGrid="0" snapToObjects="1">
      <p:cViewPr varScale="1">
        <p:scale>
          <a:sx n="116" d="100"/>
          <a:sy n="116" d="100"/>
        </p:scale>
        <p:origin x="200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5BB503-8C57-9C40-9D29-F972584CFE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96AAB65-0FD6-5946-B688-0DB09E81AA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D0FC45-8D01-664E-8FA8-73D816BA9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A4966A-73DF-7B42-ABAF-1589A6CBA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801860-6C87-2C46-96C6-EB48E4F76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039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71D34D-CABE-5C49-8333-2A7435A9D6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3B9365-48CA-4744-80B9-218DC8E8D7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009DBC-61F4-2345-B233-6AA3BE62C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CED012-1CEA-ED4A-B437-F9A1E831B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F8EA29-8424-C245-998C-30D4D8C26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906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601A44B-9EA9-834F-993A-7D3FE750A4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71019A-166B-5B4C-8327-63033F6722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C52E70-9A12-B545-A8BD-1D5E62D32D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3CC5E6-DDCE-F940-84A1-966B0A945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80ABB5-F5E8-7346-923B-53EDE1CCF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640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53431-E971-F14B-83C5-A7273CF4BD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640371-E5A8-FF4D-80D8-E0AC056FDA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C4ED84-563E-B64E-9420-379DFABCAA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994B97-1A8D-B74C-B40E-0E3D53B55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49AD80-5504-5D44-B624-17405CEF3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542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2E7D97-89D4-2F4A-9DF6-879EE1BA1B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BDC398-813A-8647-9FFF-09AC1E977F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739388-7944-BF4E-AD1E-DEC42561C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103D35-A77D-D545-91DA-40A43C2BD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715162-E975-E14E-A142-5B50F9A90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420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40B144-B7C5-E047-87CF-36A2BABD91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767D1F-4512-774E-8B05-A9664C0556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5CBBC8-DAC9-C24A-BB96-89D4A93DFB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26E39F-BEEF-234C-8658-2A5FFA7CBC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B2DC16-84C3-5E42-9046-C0C075B489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F2C1BF-89D5-1F45-A224-84B602A92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980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D41D7B-590E-134A-BC6C-74E758F589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C5940C-5905-9E4F-AC1D-7ACCD6426B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F4A31-8179-3F46-B347-159551D723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0255EF-ED47-B34B-83F4-9BE6134443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01CC7C-A387-1748-86CE-9740FC5DDD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74B288-AF82-E24E-A968-D6E126824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EB4FE09-52C2-C14C-9B25-FA94FA6F7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AD2E5DE-CE5B-2C40-8F0E-9DCF9B9C3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399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A955BE-1B94-0346-8A64-B2A94274FF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40CB24-0EC5-B04A-B83C-1205128C7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97F1E0-F102-E34C-ABB4-8C3665A57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A90711-9A7F-C746-B18F-EABAF6D97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240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C4099EA-2567-7C4B-BE00-E7DD0BAB5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4B39E1F-DD3B-6C44-9BC2-71C6B221E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C492FF8-16E3-C848-988F-FD6CBE62D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161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A23797-9B69-4642-B936-2409DA73E7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79399B-14D7-8D42-8B51-467E7BDE30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181C67-ED9D-8641-8AF5-7D640976B5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0ED884-5479-E34B-85E9-27D3A2DFA6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16BCB5-3A67-5D42-BF38-067B080373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6F0F76-A3A0-F940-B337-693A28854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17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FCCFE8-0D4B-3640-896B-479B59C4D6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B4F579-F53B-704A-BB1C-28FED2E395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974A31-AD6F-9847-A596-AD340327CF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DE4A39-CDFA-B749-9AC5-D3D65C0CE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040338-B58B-1642-AD9E-DD7F095D4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5F03EB-96B3-2346-B619-1857C78B6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784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982E0DF-6C2F-A043-8CF4-2F1F19ADBA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89BA5D-4D2D-1545-AA22-B9C3F81380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737F93-2BC9-9E40-B81F-90BCE628BA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C99DB-76CC-3A42-98EE-AB494F2F9D25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95CF8C-E7B7-794A-A9BB-D2BFA14F1D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B1C900-0984-2D44-B3E9-7F85C45700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5D257-0718-3447-9803-FD8291015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132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F1900722-BFBD-5E4F-9461-6486C25B8F9C}"/>
              </a:ext>
            </a:extLst>
          </p:cNvPr>
          <p:cNvSpPr/>
          <p:nvPr/>
        </p:nvSpPr>
        <p:spPr>
          <a:xfrm>
            <a:off x="217487" y="70452"/>
            <a:ext cx="1100328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>
                <a:latin typeface="Times New Roman" panose="02020603050405020304" pitchFamily="18" charset="0"/>
                <a:ea typeface="Times New Roman" panose="02020603050405020304" pitchFamily="18" charset="0"/>
              </a:rPr>
              <a:t>Figure S1</a:t>
            </a:r>
            <a:r>
              <a:rPr lang="en-US" sz="2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(A) log-log Kaplan Meier survival estimates against the log of time for overall survival and (B) progression-free survival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CD414F8-8376-C143-9878-718E84234FA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487" y="1529674"/>
            <a:ext cx="5716908" cy="4572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112234E-6485-314D-904B-5FE5BD319BA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5094" y="1529674"/>
            <a:ext cx="5715415" cy="45720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68659DC7-C2E5-374B-9238-9DCE5DA53C4C}"/>
              </a:ext>
            </a:extLst>
          </p:cNvPr>
          <p:cNvSpPr/>
          <p:nvPr/>
        </p:nvSpPr>
        <p:spPr>
          <a:xfrm>
            <a:off x="0" y="1298841"/>
            <a:ext cx="63154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5A9E6BF-857D-4848-ADF4-C0CF363B6C4F}"/>
              </a:ext>
            </a:extLst>
          </p:cNvPr>
          <p:cNvSpPr/>
          <p:nvPr/>
        </p:nvSpPr>
        <p:spPr>
          <a:xfrm>
            <a:off x="6258587" y="1298840"/>
            <a:ext cx="63154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endParaRPr lang="en-US" sz="2400" b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0271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32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rran, Thomas</dc:creator>
  <cp:lastModifiedBy>Curran, Thomas</cp:lastModifiedBy>
  <cp:revision>3</cp:revision>
  <dcterms:created xsi:type="dcterms:W3CDTF">2020-10-03T02:46:26Z</dcterms:created>
  <dcterms:modified xsi:type="dcterms:W3CDTF">2020-10-25T21:04:40Z</dcterms:modified>
</cp:coreProperties>
</file>